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2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感度</c:v>
                </c:pt>
              </c:strCache>
            </c:strRef>
          </c:tx>
          <c:spPr>
            <a:solidFill>
              <a:srgbClr val="00B0F0"/>
            </a:solidFill>
            <a:ln w="19050"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1575-410A-A14F-B6470933AD9A}"/>
              </c:ext>
            </c:extLst>
          </c:dPt>
          <c:dPt>
            <c:idx val="5"/>
            <c:invertIfNegative val="0"/>
            <c:bubble3D val="0"/>
            <c:spPr>
              <a:solidFill>
                <a:srgbClr val="00B0F0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1575-410A-A14F-B6470933AD9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①CIScore</c:v>
                </c:pt>
                <c:pt idx="1">
                  <c:v>②MTL</c:v>
                </c:pt>
                <c:pt idx="2">
                  <c:v>③Atrophic ratio(White matter)</c:v>
                </c:pt>
                <c:pt idx="3">
                  <c:v>①+②</c:v>
                </c:pt>
                <c:pt idx="4">
                  <c:v>①＋③</c:v>
                </c:pt>
                <c:pt idx="5">
                  <c:v>②＋③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0.74</c:v>
                </c:pt>
                <c:pt idx="1">
                  <c:v>0.69</c:v>
                </c:pt>
                <c:pt idx="2">
                  <c:v>0.56999999999999995</c:v>
                </c:pt>
                <c:pt idx="3">
                  <c:v>0.84</c:v>
                </c:pt>
                <c:pt idx="4">
                  <c:v>0.67</c:v>
                </c:pt>
                <c:pt idx="5">
                  <c:v>0.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E30-4743-B548-1511675F0E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1084160"/>
        <c:axId val="461085144"/>
      </c:barChart>
      <c:catAx>
        <c:axId val="46108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badi" panose="020B0604020104020204" pitchFamily="34" charset="0"/>
                <a:ea typeface="+mn-ea"/>
                <a:cs typeface="+mn-cs"/>
              </a:defRPr>
            </a:pPr>
            <a:endParaRPr lang="ja-JP"/>
          </a:p>
        </c:txPr>
        <c:crossAx val="461085144"/>
        <c:crosses val="autoZero"/>
        <c:auto val="1"/>
        <c:lblAlgn val="ctr"/>
        <c:lblOffset val="100"/>
        <c:noMultiLvlLbl val="0"/>
      </c:catAx>
      <c:valAx>
        <c:axId val="461085144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badi" panose="020B0604020104020204" pitchFamily="34" charset="0"/>
                <a:ea typeface="+mn-ea"/>
                <a:cs typeface="+mn-cs"/>
              </a:defRPr>
            </a:pPr>
            <a:endParaRPr lang="ja-JP"/>
          </a:p>
        </c:txPr>
        <c:crossAx val="461084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>
          <a:latin typeface="Abadi" panose="020B0604020104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5094041027632383E-2"/>
          <c:y val="8.6232135953864683E-2"/>
          <c:w val="0.90585993477037718"/>
          <c:h val="0.586044127303475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感度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dPt>
            <c:idx val="3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CA24-4A39-8E65-94BD0AB9BCF0}"/>
              </c:ext>
            </c:extLst>
          </c:dPt>
          <c:dPt>
            <c:idx val="5"/>
            <c:invertIfNegative val="0"/>
            <c:bubble3D val="0"/>
            <c:spPr>
              <a:solidFill>
                <a:srgbClr val="00B0F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A24-4A39-8E65-94BD0AB9BCF0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①CIScore</c:v>
                </c:pt>
                <c:pt idx="1">
                  <c:v>②MTL</c:v>
                </c:pt>
                <c:pt idx="2">
                  <c:v>③Atrophic ratio(white matter)</c:v>
                </c:pt>
                <c:pt idx="3">
                  <c:v>①+②</c:v>
                </c:pt>
                <c:pt idx="4">
                  <c:v>①＋③</c:v>
                </c:pt>
                <c:pt idx="5">
                  <c:v>②＋③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0.74</c:v>
                </c:pt>
                <c:pt idx="1">
                  <c:v>0.68</c:v>
                </c:pt>
                <c:pt idx="2">
                  <c:v>0.61</c:v>
                </c:pt>
                <c:pt idx="3">
                  <c:v>0.94</c:v>
                </c:pt>
                <c:pt idx="4">
                  <c:v>0.84</c:v>
                </c:pt>
                <c:pt idx="5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A24-4A39-8E65-94BD0AB9BC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1084160"/>
        <c:axId val="461085144"/>
      </c:barChart>
      <c:catAx>
        <c:axId val="461084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badi" panose="020B0604020104020204" pitchFamily="34" charset="0"/>
                <a:ea typeface="+mn-ea"/>
                <a:cs typeface="+mn-cs"/>
              </a:defRPr>
            </a:pPr>
            <a:endParaRPr lang="ja-JP"/>
          </a:p>
        </c:txPr>
        <c:crossAx val="461085144"/>
        <c:crosses val="autoZero"/>
        <c:auto val="1"/>
        <c:lblAlgn val="ctr"/>
        <c:lblOffset val="100"/>
        <c:noMultiLvlLbl val="0"/>
      </c:catAx>
      <c:valAx>
        <c:axId val="461085144"/>
        <c:scaling>
          <c:orientation val="minMax"/>
          <c:max val="1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Abadi" panose="020B0604020104020204" pitchFamily="34" charset="0"/>
                <a:ea typeface="+mn-ea"/>
                <a:cs typeface="+mn-cs"/>
              </a:defRPr>
            </a:pPr>
            <a:endParaRPr lang="ja-JP"/>
          </a:p>
        </c:txPr>
        <c:crossAx val="46108416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B22E15-4877-1766-41BC-0051BDEC81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C8B0FE9-809A-8DD7-C1D0-65459C2FF7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582C61-8F0F-6499-0162-9F1B00613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D71537-D9DF-DD4A-D0E7-17C9F6C4D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61344E-40EE-E89F-C79E-7B649B48C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29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C8D828-E23A-DADD-A1A0-AC4E7F3025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EF4E6CE-C180-AB26-BC83-5BB9FBF592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C658E8-3A06-0EA3-264A-222EA5EF6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484F31-5F24-05BF-E162-7A3E3ED0D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CF8E2B-F569-B85B-D35F-BDCF4ACDC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3281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1DFDEA7-C545-9E2F-5D27-046321FB46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AECCDCF-C27B-7CFE-7843-D5B02DE11C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88B135-ED46-0991-4602-1F33BD655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DEA544-C627-91A2-0729-A59FC3521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5D8FB3-FC2E-8B1B-C39C-33C24435B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964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AFAC5B-B457-D757-5CE7-F4DB20B2C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51F3E9-ED92-D50D-2742-BA41C706742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820640-0592-EB78-F4CA-A7DA9217A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A6504CC-C2F7-E52B-BD24-D327A1FC3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B59AA9-975D-0876-FD56-210073445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81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AC0935-381C-C5A6-B4D8-C19436069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884E94-A116-14D6-B8A6-0530A44B44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C19586-E115-DEE9-362D-CACC4E916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ADEEA2-A285-DF0F-0863-0A448EF2B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5A0A05C-8488-2F4D-8EB9-F3392C8CB5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6422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9BF3B28-62E2-EC57-3DDE-0438D22E4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46855E-BB08-38E6-D237-0EC3DEE536D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3806852-6BAD-69EC-E938-A10F858368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7DBF46-19BF-8391-38F8-84DD64A80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16E7DB-2EB6-25AC-1DEE-204B54F31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2FA7D17-48CF-47AB-CFA6-95AA79FFB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7797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03420-122B-07A2-78DE-090F169195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CED201-576B-57F4-4631-17B715BBEB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027B4BC-3734-48D1-3E19-031F04F1A4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D167860-F24E-79CA-637E-B515B64D45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1A6E508-7F6A-2B3E-250A-4692E173B1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24ACE7-A19D-3DD0-C14C-D2289958B9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9149F4B-863D-D322-F433-2C33AF02F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05957F6-E545-2168-BA10-C0BCD0E3A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954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25E37DC-C844-5094-FFD4-B7E854D55A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135EE80-0D84-961E-8205-10B2A2058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ACC5358-FAD0-DBF6-E105-603FBABA6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D0EB62F-78EE-54FC-70DA-46E407DE5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683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7E73ADB-2B7A-6F1F-805E-857A446AE9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E9820EB-A4FB-83ED-EA50-05806050A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F327D15-3A5C-AC05-9094-C2EF95362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309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DD12AC-253E-69C0-6FF1-6B2C60AFBB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DDF5684-0AAB-1B9E-92D9-E02EF64617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29FBB9-9ED7-770E-AB5D-26BA75B57D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7A30C7-50D5-8557-A479-0058973EA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B43289E-568B-10CD-4481-DD27DD5C9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4B009A-6715-560F-9921-317AB92B5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41781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5C26AD3-EAFB-21B8-E7A8-9FD7CC86FA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9ABC61D-3183-F668-483C-EF86E0F576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F3DDF2-1542-6869-BF82-2166E52BD2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312F97-71C3-82EA-448B-03D08B728A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4041F5-00AF-1B3F-D052-76FD188D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A785FF-6A38-6B6C-EE1B-C341D999E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834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1E8CE52-AA03-1F68-A399-836FF7C5C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5665EEF-CF64-92AB-ACCF-7DB053FA9A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04532E-CD6A-87C9-F7C4-E5354E75FE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D689B0A-F440-4D7F-A9DA-E8C39C869ECD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77D1D9-2559-4116-6EE6-8C9C127F84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A883C3-A7FC-9345-264D-805BB2673A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368E6C-C8BE-478F-B8CB-0B7079C97E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3369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コンテンツ プレースホルダー 5">
            <a:extLst>
              <a:ext uri="{FF2B5EF4-FFF2-40B4-BE49-F238E27FC236}">
                <a16:creationId xmlns:a16="http://schemas.microsoft.com/office/drawing/2014/main" id="{3202018A-1083-4839-C6CC-0B0C957B7A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1448825"/>
              </p:ext>
            </p:extLst>
          </p:nvPr>
        </p:nvGraphicFramePr>
        <p:xfrm>
          <a:off x="1379626" y="1657433"/>
          <a:ext cx="9141132" cy="38714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E31F7E6-DB9B-BFFB-56D4-4EC1191A61E1}"/>
              </a:ext>
            </a:extLst>
          </p:cNvPr>
          <p:cNvGrpSpPr/>
          <p:nvPr/>
        </p:nvGrpSpPr>
        <p:grpSpPr>
          <a:xfrm>
            <a:off x="5397880" y="1542180"/>
            <a:ext cx="1396240" cy="611294"/>
            <a:chOff x="4942115" y="1323942"/>
            <a:chExt cx="1521106" cy="522526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70F2C71B-A6BA-FD4B-7CE5-309D298989AA}"/>
                </a:ext>
              </a:extLst>
            </p:cNvPr>
            <p:cNvSpPr txBox="1"/>
            <p:nvPr/>
          </p:nvSpPr>
          <p:spPr>
            <a:xfrm>
              <a:off x="5414331" y="1323942"/>
              <a:ext cx="377190" cy="4472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28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＊</a:t>
              </a: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7E378C71-D5F2-E2B1-D476-B8CF639D0631}"/>
                </a:ext>
              </a:extLst>
            </p:cNvPr>
            <p:cNvCxnSpPr>
              <a:cxnSpLocks/>
            </p:cNvCxnSpPr>
            <p:nvPr/>
          </p:nvCxnSpPr>
          <p:spPr>
            <a:xfrm>
              <a:off x="4949372" y="1536487"/>
              <a:ext cx="40639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A1BB1C5A-58FE-057D-B69F-2BA18CB42959}"/>
                </a:ext>
              </a:extLst>
            </p:cNvPr>
            <p:cNvCxnSpPr>
              <a:cxnSpLocks/>
            </p:cNvCxnSpPr>
            <p:nvPr/>
          </p:nvCxnSpPr>
          <p:spPr>
            <a:xfrm>
              <a:off x="6056822" y="1532623"/>
              <a:ext cx="406399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52313CD9-73E6-A84C-E4E2-18F577B2D201}"/>
                </a:ext>
              </a:extLst>
            </p:cNvPr>
            <p:cNvCxnSpPr>
              <a:cxnSpLocks/>
            </p:cNvCxnSpPr>
            <p:nvPr/>
          </p:nvCxnSpPr>
          <p:spPr>
            <a:xfrm>
              <a:off x="4942115" y="1531294"/>
              <a:ext cx="0" cy="31384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91BD61F6-9F11-DB79-1206-05870748E570}"/>
                </a:ext>
              </a:extLst>
            </p:cNvPr>
            <p:cNvCxnSpPr>
              <a:cxnSpLocks/>
            </p:cNvCxnSpPr>
            <p:nvPr/>
          </p:nvCxnSpPr>
          <p:spPr>
            <a:xfrm>
              <a:off x="6463221" y="1532623"/>
              <a:ext cx="0" cy="31384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" name="タイトル 1">
            <a:extLst>
              <a:ext uri="{FF2B5EF4-FFF2-40B4-BE49-F238E27FC236}">
                <a16:creationId xmlns:a16="http://schemas.microsoft.com/office/drawing/2014/main" id="{9F34A01B-4D72-9556-087E-AE2D78C63099}"/>
              </a:ext>
            </a:extLst>
          </p:cNvPr>
          <p:cNvSpPr txBox="1">
            <a:spLocks/>
          </p:cNvSpPr>
          <p:nvPr/>
        </p:nvSpPr>
        <p:spPr>
          <a:xfrm>
            <a:off x="4924576" y="6053704"/>
            <a:ext cx="2676258" cy="5492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solidFill>
                  <a:srgbClr val="FF0000"/>
                </a:solidFill>
                <a:latin typeface="Abadi" panose="020B0604020104020204" pitchFamily="34" charset="0"/>
                <a:ea typeface="ＭＳ ゴシック" panose="020B0609070205080204" pitchFamily="49" charset="-128"/>
              </a:rPr>
              <a:t>Online Resource 1</a:t>
            </a:r>
            <a:r>
              <a:rPr lang="ja-JP" altLang="en-US" sz="2400" dirty="0">
                <a:solidFill>
                  <a:srgbClr val="FF0000"/>
                </a:solidFill>
                <a:latin typeface="Abadi" panose="020B0604020104020204" pitchFamily="34" charset="0"/>
                <a:ea typeface="ＭＳ ゴシック" panose="020B0609070205080204" pitchFamily="49" charset="-128"/>
              </a:rPr>
              <a:t> 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5440197-0C69-CDED-2ED6-68CBD57A8ACF}"/>
              </a:ext>
            </a:extLst>
          </p:cNvPr>
          <p:cNvSpPr txBox="1"/>
          <p:nvPr/>
        </p:nvSpPr>
        <p:spPr>
          <a:xfrm>
            <a:off x="666750" y="1132660"/>
            <a:ext cx="18710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>
                <a:latin typeface="Arial" panose="020B0604020202020204" pitchFamily="34" charset="0"/>
                <a:cs typeface="Arial" panose="020B0604020202020204" pitchFamily="34" charset="0"/>
              </a:rPr>
              <a:t>Accuracy</a:t>
            </a:r>
            <a:endParaRPr kumimoji="1" lang="ja-JP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EE2952E-28FA-2D54-1C9A-88E495236E5B}"/>
              </a:ext>
            </a:extLst>
          </p:cNvPr>
          <p:cNvSpPr txBox="1"/>
          <p:nvPr/>
        </p:nvSpPr>
        <p:spPr>
          <a:xfrm>
            <a:off x="10038236" y="621183"/>
            <a:ext cx="207756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2000" dirty="0">
                <a:solidFill>
                  <a:srgbClr val="FF0000"/>
                </a:solidFill>
              </a:rPr>
              <a:t>＊</a:t>
            </a:r>
            <a:r>
              <a:rPr lang="en-US" altLang="ja-JP" sz="2000" dirty="0">
                <a:solidFill>
                  <a:srgbClr val="FFC000"/>
                </a:solidFill>
              </a:rPr>
              <a:t>:</a:t>
            </a:r>
            <a:r>
              <a:rPr lang="ja-JP" altLang="en-US" sz="2000" dirty="0"/>
              <a:t>＜</a:t>
            </a:r>
            <a:r>
              <a:rPr lang="en-US" altLang="ja-JP" sz="2000" dirty="0"/>
              <a:t>0.05</a:t>
            </a:r>
          </a:p>
          <a:p>
            <a:r>
              <a:rPr lang="en-US" altLang="ja-JP" sz="2000" dirty="0"/>
              <a:t>McNemar test</a:t>
            </a:r>
            <a:endParaRPr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272228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コンテンツ プレースホルダー 5">
            <a:extLst>
              <a:ext uri="{FF2B5EF4-FFF2-40B4-BE49-F238E27FC236}">
                <a16:creationId xmlns:a16="http://schemas.microsoft.com/office/drawing/2014/main" id="{60272307-3E91-C7BD-B0DB-2A52A3BBC27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30138"/>
              </p:ext>
            </p:extLst>
          </p:nvPr>
        </p:nvGraphicFramePr>
        <p:xfrm>
          <a:off x="1063261" y="1843664"/>
          <a:ext cx="10239148" cy="42086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FF279937-76C2-ABC6-839A-0BDCF729C852}"/>
              </a:ext>
            </a:extLst>
          </p:cNvPr>
          <p:cNvGrpSpPr/>
          <p:nvPr/>
        </p:nvGrpSpPr>
        <p:grpSpPr>
          <a:xfrm>
            <a:off x="7387179" y="1670340"/>
            <a:ext cx="1389967" cy="523220"/>
            <a:chOff x="4942115" y="1183168"/>
            <a:chExt cx="1397198" cy="697627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82AC3873-54F6-30C5-E9FD-12E0EB554EFA}"/>
                </a:ext>
              </a:extLst>
            </p:cNvPr>
            <p:cNvSpPr txBox="1"/>
            <p:nvPr/>
          </p:nvSpPr>
          <p:spPr>
            <a:xfrm>
              <a:off x="5376437" y="1183168"/>
              <a:ext cx="377190" cy="6976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2800" dirty="0">
                  <a:solidFill>
                    <a:srgbClr val="FF0000"/>
                  </a:solidFill>
                </a:rPr>
                <a:t>＊</a:t>
              </a:r>
            </a:p>
          </p:txBody>
        </p: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id="{26DFC787-B654-D6B3-E5D5-74B49C4B033F}"/>
                </a:ext>
              </a:extLst>
            </p:cNvPr>
            <p:cNvCxnSpPr>
              <a:cxnSpLocks/>
            </p:cNvCxnSpPr>
            <p:nvPr/>
          </p:nvCxnSpPr>
          <p:spPr>
            <a:xfrm>
              <a:off x="4949372" y="1532876"/>
              <a:ext cx="4064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0E65B44C-57C8-BD93-2A23-EA49D7408444}"/>
                </a:ext>
              </a:extLst>
            </p:cNvPr>
            <p:cNvCxnSpPr>
              <a:cxnSpLocks/>
            </p:cNvCxnSpPr>
            <p:nvPr/>
          </p:nvCxnSpPr>
          <p:spPr>
            <a:xfrm>
              <a:off x="5929086" y="1531982"/>
              <a:ext cx="4064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B0A01BA9-1610-40E7-9A33-A1CD9F0E04EE}"/>
                </a:ext>
              </a:extLst>
            </p:cNvPr>
            <p:cNvCxnSpPr>
              <a:cxnSpLocks/>
            </p:cNvCxnSpPr>
            <p:nvPr/>
          </p:nvCxnSpPr>
          <p:spPr>
            <a:xfrm>
              <a:off x="4942115" y="1555541"/>
              <a:ext cx="0" cy="31384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コネクタ 8">
              <a:extLst>
                <a:ext uri="{FF2B5EF4-FFF2-40B4-BE49-F238E27FC236}">
                  <a16:creationId xmlns:a16="http://schemas.microsoft.com/office/drawing/2014/main" id="{21E44253-D8AB-65B1-172F-91BDEF572810}"/>
                </a:ext>
              </a:extLst>
            </p:cNvPr>
            <p:cNvCxnSpPr>
              <a:cxnSpLocks/>
            </p:cNvCxnSpPr>
            <p:nvPr/>
          </p:nvCxnSpPr>
          <p:spPr>
            <a:xfrm>
              <a:off x="6339313" y="1541363"/>
              <a:ext cx="0" cy="31384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5429C812-FAA7-006B-2326-9085ECC38D56}"/>
              </a:ext>
            </a:extLst>
          </p:cNvPr>
          <p:cNvCxnSpPr>
            <a:cxnSpLocks/>
          </p:cNvCxnSpPr>
          <p:nvPr/>
        </p:nvCxnSpPr>
        <p:spPr>
          <a:xfrm>
            <a:off x="2635573" y="1876082"/>
            <a:ext cx="4590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8155BF10-8288-F042-1973-932AD18B430F}"/>
              </a:ext>
            </a:extLst>
          </p:cNvPr>
          <p:cNvGrpSpPr/>
          <p:nvPr/>
        </p:nvGrpSpPr>
        <p:grpSpPr>
          <a:xfrm>
            <a:off x="7215467" y="1622605"/>
            <a:ext cx="3152487" cy="584202"/>
            <a:chOff x="4942115" y="1643811"/>
            <a:chExt cx="1343778" cy="548056"/>
          </a:xfrm>
        </p:grpSpPr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55C04A07-7645-F116-06B0-F5D6F4DA74A9}"/>
                </a:ext>
              </a:extLst>
            </p:cNvPr>
            <p:cNvCxnSpPr>
              <a:cxnSpLocks/>
            </p:cNvCxnSpPr>
            <p:nvPr/>
          </p:nvCxnSpPr>
          <p:spPr>
            <a:xfrm>
              <a:off x="4942115" y="1660155"/>
              <a:ext cx="54615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2AEA21B4-792D-E435-6019-456D8526C497}"/>
                </a:ext>
              </a:extLst>
            </p:cNvPr>
            <p:cNvCxnSpPr>
              <a:cxnSpLocks/>
            </p:cNvCxnSpPr>
            <p:nvPr/>
          </p:nvCxnSpPr>
          <p:spPr>
            <a:xfrm>
              <a:off x="5765036" y="1671250"/>
              <a:ext cx="51492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79FD6B7F-9724-94A8-D350-E98BE1121ED6}"/>
                </a:ext>
              </a:extLst>
            </p:cNvPr>
            <p:cNvCxnSpPr>
              <a:cxnSpLocks/>
            </p:cNvCxnSpPr>
            <p:nvPr/>
          </p:nvCxnSpPr>
          <p:spPr>
            <a:xfrm>
              <a:off x="4946647" y="1645479"/>
              <a:ext cx="0" cy="406005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B89D45EF-C7A4-90C5-6CEC-449896F1BC3F}"/>
                </a:ext>
              </a:extLst>
            </p:cNvPr>
            <p:cNvCxnSpPr>
              <a:cxnSpLocks/>
            </p:cNvCxnSpPr>
            <p:nvPr/>
          </p:nvCxnSpPr>
          <p:spPr>
            <a:xfrm>
              <a:off x="6285893" y="1643811"/>
              <a:ext cx="0" cy="548056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A8DDBF7-D21C-3712-16F5-0B281540D22F}"/>
              </a:ext>
            </a:extLst>
          </p:cNvPr>
          <p:cNvSpPr txBox="1"/>
          <p:nvPr/>
        </p:nvSpPr>
        <p:spPr>
          <a:xfrm>
            <a:off x="8551531" y="1386871"/>
            <a:ext cx="3771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800" dirty="0">
                <a:solidFill>
                  <a:srgbClr val="FF0000"/>
                </a:solidFill>
              </a:rPr>
              <a:t>＊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FF44C53-9253-8120-8A69-1348636D74B1}"/>
              </a:ext>
            </a:extLst>
          </p:cNvPr>
          <p:cNvSpPr txBox="1"/>
          <p:nvPr/>
        </p:nvSpPr>
        <p:spPr>
          <a:xfrm>
            <a:off x="3902124" y="2001512"/>
            <a:ext cx="3771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800" dirty="0">
                <a:solidFill>
                  <a:srgbClr val="FF0000"/>
                </a:solidFill>
              </a:rPr>
              <a:t>＊</a:t>
            </a: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25F9C86F-C52F-D0BB-4A4A-586C1006107A}"/>
              </a:ext>
            </a:extLst>
          </p:cNvPr>
          <p:cNvCxnSpPr>
            <a:cxnSpLocks/>
          </p:cNvCxnSpPr>
          <p:nvPr/>
        </p:nvCxnSpPr>
        <p:spPr>
          <a:xfrm>
            <a:off x="4170951" y="2412590"/>
            <a:ext cx="0" cy="46301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23063429-C836-62BD-CFFB-017574815A9F}"/>
              </a:ext>
            </a:extLst>
          </p:cNvPr>
          <p:cNvCxnSpPr>
            <a:cxnSpLocks/>
          </p:cNvCxnSpPr>
          <p:nvPr/>
        </p:nvCxnSpPr>
        <p:spPr>
          <a:xfrm>
            <a:off x="4154317" y="1892457"/>
            <a:ext cx="0" cy="16698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536FEFE-F7C1-A1AC-F7F2-FA5A8DC5869C}"/>
              </a:ext>
            </a:extLst>
          </p:cNvPr>
          <p:cNvSpPr txBox="1"/>
          <p:nvPr/>
        </p:nvSpPr>
        <p:spPr>
          <a:xfrm>
            <a:off x="5420867" y="2017519"/>
            <a:ext cx="3771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800" dirty="0">
                <a:solidFill>
                  <a:srgbClr val="FF0000"/>
                </a:solidFill>
              </a:rPr>
              <a:t>＊</a:t>
            </a: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E3420715-323A-D7F5-CD7B-38445C7E7774}"/>
              </a:ext>
            </a:extLst>
          </p:cNvPr>
          <p:cNvCxnSpPr>
            <a:cxnSpLocks/>
          </p:cNvCxnSpPr>
          <p:nvPr/>
        </p:nvCxnSpPr>
        <p:spPr>
          <a:xfrm>
            <a:off x="5691244" y="2426740"/>
            <a:ext cx="0" cy="448866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9AEF061E-6BD5-9D1C-857E-6DB493FC1C1E}"/>
              </a:ext>
            </a:extLst>
          </p:cNvPr>
          <p:cNvCxnSpPr>
            <a:cxnSpLocks/>
          </p:cNvCxnSpPr>
          <p:nvPr/>
        </p:nvCxnSpPr>
        <p:spPr>
          <a:xfrm>
            <a:off x="5684892" y="1876082"/>
            <a:ext cx="0" cy="26559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AC6E510-7447-C0D7-A972-0B59844E1673}"/>
              </a:ext>
            </a:extLst>
          </p:cNvPr>
          <p:cNvSpPr txBox="1"/>
          <p:nvPr/>
        </p:nvSpPr>
        <p:spPr>
          <a:xfrm>
            <a:off x="2365258" y="2022271"/>
            <a:ext cx="37719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2800" dirty="0">
                <a:solidFill>
                  <a:srgbClr val="FF0000"/>
                </a:solidFill>
              </a:rPr>
              <a:t>＊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F4C1D73C-5FE0-901E-261C-CDA079CFE357}"/>
              </a:ext>
            </a:extLst>
          </p:cNvPr>
          <p:cNvCxnSpPr>
            <a:cxnSpLocks/>
          </p:cNvCxnSpPr>
          <p:nvPr/>
        </p:nvCxnSpPr>
        <p:spPr>
          <a:xfrm>
            <a:off x="2635573" y="2412590"/>
            <a:ext cx="0" cy="22428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6BC2DA1-23A4-5D6A-E358-93E221546C92}"/>
              </a:ext>
            </a:extLst>
          </p:cNvPr>
          <p:cNvCxnSpPr>
            <a:cxnSpLocks/>
          </p:cNvCxnSpPr>
          <p:nvPr/>
        </p:nvCxnSpPr>
        <p:spPr>
          <a:xfrm>
            <a:off x="2635573" y="2140538"/>
            <a:ext cx="0" cy="29982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7AF98BF-EB87-8509-0C40-393EDDF732C6}"/>
              </a:ext>
            </a:extLst>
          </p:cNvPr>
          <p:cNvSpPr txBox="1"/>
          <p:nvPr/>
        </p:nvSpPr>
        <p:spPr>
          <a:xfrm>
            <a:off x="9990611" y="361630"/>
            <a:ext cx="207756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2000" dirty="0">
                <a:solidFill>
                  <a:srgbClr val="FF0000"/>
                </a:solidFill>
              </a:rPr>
              <a:t>＊</a:t>
            </a:r>
            <a:r>
              <a:rPr lang="en-US" altLang="ja-JP" sz="2000" dirty="0">
                <a:solidFill>
                  <a:srgbClr val="FFC000"/>
                </a:solidFill>
              </a:rPr>
              <a:t>:</a:t>
            </a:r>
            <a:r>
              <a:rPr lang="ja-JP" altLang="en-US" sz="2000" dirty="0"/>
              <a:t>＜</a:t>
            </a:r>
            <a:r>
              <a:rPr lang="en-US" altLang="ja-JP" sz="2000" dirty="0"/>
              <a:t>0.05</a:t>
            </a:r>
          </a:p>
          <a:p>
            <a:r>
              <a:rPr lang="en-US" altLang="ja-JP" sz="2000" dirty="0"/>
              <a:t>McNemar test</a:t>
            </a:r>
            <a:endParaRPr lang="ja-JP" altLang="en-US" sz="2000" dirty="0"/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ED1DFA2-0161-B8E3-B549-383935F793D1}"/>
              </a:ext>
            </a:extLst>
          </p:cNvPr>
          <p:cNvCxnSpPr>
            <a:cxnSpLocks/>
          </p:cNvCxnSpPr>
          <p:nvPr/>
        </p:nvCxnSpPr>
        <p:spPr>
          <a:xfrm>
            <a:off x="2635573" y="1850804"/>
            <a:ext cx="0" cy="20863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DD2B74A-51C2-F999-1494-AE5D5CAA5685}"/>
              </a:ext>
            </a:extLst>
          </p:cNvPr>
          <p:cNvSpPr txBox="1"/>
          <p:nvPr/>
        </p:nvSpPr>
        <p:spPr>
          <a:xfrm>
            <a:off x="446874" y="1157071"/>
            <a:ext cx="172835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dirty="0">
                <a:latin typeface="Abadi" panose="020B0604020104020204" pitchFamily="34" charset="0"/>
              </a:rPr>
              <a:t>Accuracy</a:t>
            </a:r>
            <a:endParaRPr kumimoji="1" lang="ja-JP" altLang="en-US" sz="3200" dirty="0">
              <a:latin typeface="Abadi" panose="020B0604020104020204" pitchFamily="34" charset="0"/>
            </a:endParaRPr>
          </a:p>
        </p:txBody>
      </p:sp>
      <p:sp>
        <p:nvSpPr>
          <p:cNvPr id="28" name="タイトル 1">
            <a:extLst>
              <a:ext uri="{FF2B5EF4-FFF2-40B4-BE49-F238E27FC236}">
                <a16:creationId xmlns:a16="http://schemas.microsoft.com/office/drawing/2014/main" id="{409A8CE1-97E2-2432-BF05-3778642AC23D}"/>
              </a:ext>
            </a:extLst>
          </p:cNvPr>
          <p:cNvSpPr txBox="1">
            <a:spLocks/>
          </p:cNvSpPr>
          <p:nvPr/>
        </p:nvSpPr>
        <p:spPr>
          <a:xfrm>
            <a:off x="4920288" y="6154145"/>
            <a:ext cx="2676258" cy="549231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>
                <a:solidFill>
                  <a:srgbClr val="FF0000"/>
                </a:solidFill>
                <a:latin typeface="Abadi" panose="020B0604020104020204" pitchFamily="34" charset="0"/>
                <a:ea typeface="ＭＳ ゴシック" panose="020B0609070205080204" pitchFamily="49" charset="-128"/>
              </a:rPr>
              <a:t>Online Resource 2</a:t>
            </a:r>
            <a:r>
              <a:rPr lang="ja-JP" altLang="en-US" sz="2400" dirty="0">
                <a:solidFill>
                  <a:srgbClr val="FF0000"/>
                </a:solidFill>
                <a:latin typeface="Abadi" panose="020B0604020104020204" pitchFamily="34" charset="0"/>
                <a:ea typeface="ＭＳ ゴシック" panose="020B0609070205080204" pitchFamily="49" charset="-128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5462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6</Words>
  <Application>Microsoft Office PowerPoint</Application>
  <PresentationFormat>ワイド画面</PresentationFormat>
  <Paragraphs>1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badi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がく ほんだ</dc:creator>
  <cp:lastModifiedBy>茂樹長町</cp:lastModifiedBy>
  <cp:revision>2</cp:revision>
  <dcterms:created xsi:type="dcterms:W3CDTF">2024-05-07T04:45:31Z</dcterms:created>
  <dcterms:modified xsi:type="dcterms:W3CDTF">2024-05-12T08:36:47Z</dcterms:modified>
</cp:coreProperties>
</file>